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15"/>
    <p:restoredTop sz="96327"/>
  </p:normalViewPr>
  <p:slideViewPr>
    <p:cSldViewPr snapToGrid="0">
      <p:cViewPr varScale="1">
        <p:scale>
          <a:sx n="114" d="100"/>
          <a:sy n="114" d="100"/>
        </p:scale>
        <p:origin x="160" y="3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4AC42-2F4B-AE40-AC1B-8CDC3AACFDE5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AE03E-49FA-AF4E-ADD9-BB0E74436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441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4AC42-2F4B-AE40-AC1B-8CDC3AACFDE5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AE03E-49FA-AF4E-ADD9-BB0E74436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761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4AC42-2F4B-AE40-AC1B-8CDC3AACFDE5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AE03E-49FA-AF4E-ADD9-BB0E74436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4551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4AC42-2F4B-AE40-AC1B-8CDC3AACFDE5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AE03E-49FA-AF4E-ADD9-BB0E74436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833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4AC42-2F4B-AE40-AC1B-8CDC3AACFDE5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AE03E-49FA-AF4E-ADD9-BB0E74436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462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4AC42-2F4B-AE40-AC1B-8CDC3AACFDE5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AE03E-49FA-AF4E-ADD9-BB0E74436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461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4AC42-2F4B-AE40-AC1B-8CDC3AACFDE5}" type="datetimeFigureOut">
              <a:rPr lang="en-US" smtClean="0"/>
              <a:t>3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AE03E-49FA-AF4E-ADD9-BB0E74436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473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4AC42-2F4B-AE40-AC1B-8CDC3AACFDE5}" type="datetimeFigureOut">
              <a:rPr lang="en-US" smtClean="0"/>
              <a:t>3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AE03E-49FA-AF4E-ADD9-BB0E74436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719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4AC42-2F4B-AE40-AC1B-8CDC3AACFDE5}" type="datetimeFigureOut">
              <a:rPr lang="en-US" smtClean="0"/>
              <a:t>3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AE03E-49FA-AF4E-ADD9-BB0E74436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926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4AC42-2F4B-AE40-AC1B-8CDC3AACFDE5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AE03E-49FA-AF4E-ADD9-BB0E74436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327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4AC42-2F4B-AE40-AC1B-8CDC3AACFDE5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AE03E-49FA-AF4E-ADD9-BB0E74436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535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4AC42-2F4B-AE40-AC1B-8CDC3AACFDE5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6AE03E-49FA-AF4E-ADD9-BB0E74436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106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3EC6D87B-4976-42E2-59C9-31D34D352AB1}"/>
              </a:ext>
            </a:extLst>
          </p:cNvPr>
          <p:cNvSpPr txBox="1"/>
          <p:nvPr/>
        </p:nvSpPr>
        <p:spPr>
          <a:xfrm>
            <a:off x="5443958" y="8746435"/>
            <a:ext cx="11480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 Figure 1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553B62D6-FF4D-AA7E-7285-278E07600D04}"/>
              </a:ext>
            </a:extLst>
          </p:cNvPr>
          <p:cNvGrpSpPr/>
          <p:nvPr/>
        </p:nvGrpSpPr>
        <p:grpSpPr>
          <a:xfrm>
            <a:off x="-33855" y="1121668"/>
            <a:ext cx="6925710" cy="6900665"/>
            <a:chOff x="-33855" y="1232776"/>
            <a:chExt cx="6925710" cy="6900665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5EF72424-BBB1-A6B7-CF63-A14B69634E03}"/>
                </a:ext>
              </a:extLst>
            </p:cNvPr>
            <p:cNvGrpSpPr/>
            <p:nvPr/>
          </p:nvGrpSpPr>
          <p:grpSpPr>
            <a:xfrm>
              <a:off x="-33855" y="1232776"/>
              <a:ext cx="6925710" cy="5455746"/>
              <a:chOff x="-144837" y="2122536"/>
              <a:chExt cx="6925710" cy="5455746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E73F4232-09B0-DEB2-CD26-E36B373AFDEF}"/>
                  </a:ext>
                </a:extLst>
              </p:cNvPr>
              <p:cNvGrpSpPr/>
              <p:nvPr/>
            </p:nvGrpSpPr>
            <p:grpSpPr>
              <a:xfrm>
                <a:off x="-144837" y="2122536"/>
                <a:ext cx="6925710" cy="2749293"/>
                <a:chOff x="-96744" y="4475650"/>
                <a:chExt cx="6925710" cy="2749293"/>
              </a:xfrm>
            </p:grpSpPr>
            <p:grpSp>
              <p:nvGrpSpPr>
                <p:cNvPr id="18" name="Group 17">
                  <a:extLst>
                    <a:ext uri="{FF2B5EF4-FFF2-40B4-BE49-F238E27FC236}">
                      <a16:creationId xmlns:a16="http://schemas.microsoft.com/office/drawing/2014/main" id="{95430736-B84C-41A1-AC75-4268BE0CC21B}"/>
                    </a:ext>
                  </a:extLst>
                </p:cNvPr>
                <p:cNvGrpSpPr/>
                <p:nvPr/>
              </p:nvGrpSpPr>
              <p:grpSpPr>
                <a:xfrm>
                  <a:off x="-96744" y="4475650"/>
                  <a:ext cx="6925710" cy="2749293"/>
                  <a:chOff x="-96744" y="4435534"/>
                  <a:chExt cx="6925710" cy="2746026"/>
                </a:xfrm>
              </p:grpSpPr>
              <p:sp>
                <p:nvSpPr>
                  <p:cNvPr id="9" name="TextBox 8">
                    <a:extLst>
                      <a:ext uri="{FF2B5EF4-FFF2-40B4-BE49-F238E27FC236}">
                        <a16:creationId xmlns:a16="http://schemas.microsoft.com/office/drawing/2014/main" id="{8BB17E71-FE18-4CB1-AE11-6E2454137E03}"/>
                      </a:ext>
                    </a:extLst>
                  </p:cNvPr>
                  <p:cNvSpPr txBox="1"/>
                  <p:nvPr/>
                </p:nvSpPr>
                <p:spPr>
                  <a:xfrm>
                    <a:off x="1603793" y="4665215"/>
                    <a:ext cx="639919" cy="2612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trong</a:t>
                    </a:r>
                  </a:p>
                </p:txBody>
              </p:sp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B529EBD0-81FC-4A1C-AB33-E686613368B4}"/>
                      </a:ext>
                    </a:extLst>
                  </p:cNvPr>
                  <p:cNvSpPr txBox="1"/>
                  <p:nvPr/>
                </p:nvSpPr>
                <p:spPr>
                  <a:xfrm>
                    <a:off x="3126677" y="4665215"/>
                    <a:ext cx="811441" cy="2612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oderate</a:t>
                    </a:r>
                  </a:p>
                </p:txBody>
              </p:sp>
              <p:sp>
                <p:nvSpPr>
                  <p:cNvPr id="11" name="TextBox 10">
                    <a:extLst>
                      <a:ext uri="{FF2B5EF4-FFF2-40B4-BE49-F238E27FC236}">
                        <a16:creationId xmlns:a16="http://schemas.microsoft.com/office/drawing/2014/main" id="{BB00A850-AA1C-4FD2-8B44-C4CBCFCC9813}"/>
                      </a:ext>
                    </a:extLst>
                  </p:cNvPr>
                  <p:cNvSpPr txBox="1"/>
                  <p:nvPr/>
                </p:nvSpPr>
                <p:spPr>
                  <a:xfrm>
                    <a:off x="5123325" y="4665215"/>
                    <a:ext cx="553357" cy="2612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eak</a:t>
                    </a:r>
                  </a:p>
                </p:txBody>
              </p:sp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0C1C6DBC-2738-4DBB-9A32-AA426AEB5ACE}"/>
                      </a:ext>
                    </a:extLst>
                  </p:cNvPr>
                  <p:cNvSpPr txBox="1"/>
                  <p:nvPr/>
                </p:nvSpPr>
                <p:spPr>
                  <a:xfrm>
                    <a:off x="40590" y="4987276"/>
                    <a:ext cx="1061509" cy="2612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ntire Tumor</a:t>
                    </a:r>
                  </a:p>
                </p:txBody>
              </p:sp>
              <p:sp>
                <p:nvSpPr>
                  <p:cNvPr id="16" name="Rectangle 15">
                    <a:extLst>
                      <a:ext uri="{FF2B5EF4-FFF2-40B4-BE49-F238E27FC236}">
                        <a16:creationId xmlns:a16="http://schemas.microsoft.com/office/drawing/2014/main" id="{6CF2771F-2818-4C16-AA4D-8A7CA2C38BAD}"/>
                      </a:ext>
                    </a:extLst>
                  </p:cNvPr>
                  <p:cNvSpPr/>
                  <p:nvPr/>
                </p:nvSpPr>
                <p:spPr>
                  <a:xfrm>
                    <a:off x="-96744" y="4549264"/>
                    <a:ext cx="6925710" cy="2632296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C84E0DE9-ABEC-4DCE-B668-2EF32D6D183B}"/>
                      </a:ext>
                    </a:extLst>
                  </p:cNvPr>
                  <p:cNvSpPr txBox="1"/>
                  <p:nvPr/>
                </p:nvSpPr>
                <p:spPr>
                  <a:xfrm>
                    <a:off x="328543" y="4435534"/>
                    <a:ext cx="295274" cy="27667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</a:p>
                </p:txBody>
              </p:sp>
            </p:grpSp>
            <p:grpSp>
              <p:nvGrpSpPr>
                <p:cNvPr id="21" name="Group 20">
                  <a:extLst>
                    <a:ext uri="{FF2B5EF4-FFF2-40B4-BE49-F238E27FC236}">
                      <a16:creationId xmlns:a16="http://schemas.microsoft.com/office/drawing/2014/main" id="{303D35DC-CC6E-3E5C-4BE5-804FC18B30BD}"/>
                    </a:ext>
                  </a:extLst>
                </p:cNvPr>
                <p:cNvGrpSpPr/>
                <p:nvPr/>
              </p:nvGrpSpPr>
              <p:grpSpPr>
                <a:xfrm>
                  <a:off x="1201457" y="4932323"/>
                  <a:ext cx="4830036" cy="1487885"/>
                  <a:chOff x="1124551" y="4937427"/>
                  <a:chExt cx="4958519" cy="1579408"/>
                </a:xfrm>
              </p:grpSpPr>
              <p:pic>
                <p:nvPicPr>
                  <p:cNvPr id="8" name="Picture 7">
                    <a:extLst>
                      <a:ext uri="{FF2B5EF4-FFF2-40B4-BE49-F238E27FC236}">
                        <a16:creationId xmlns:a16="http://schemas.microsoft.com/office/drawing/2014/main" id="{F07B3150-C688-469D-3B60-9D3C98E2AE5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1124551" y="5045292"/>
                    <a:ext cx="1413834" cy="1471543"/>
                  </a:xfrm>
                  <a:prstGeom prst="rect">
                    <a:avLst/>
                  </a:prstGeom>
                </p:spPr>
              </p:pic>
              <p:pic>
                <p:nvPicPr>
                  <p:cNvPr id="19" name="Picture 18">
                    <a:extLst>
                      <a:ext uri="{FF2B5EF4-FFF2-40B4-BE49-F238E27FC236}">
                        <a16:creationId xmlns:a16="http://schemas.microsoft.com/office/drawing/2014/main" id="{B3173BC0-CAD6-1944-47D3-E8E3C942859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2796986" y="4951496"/>
                    <a:ext cx="1382636" cy="1551080"/>
                  </a:xfrm>
                  <a:prstGeom prst="rect">
                    <a:avLst/>
                  </a:prstGeom>
                </p:spPr>
              </p:pic>
              <p:pic>
                <p:nvPicPr>
                  <p:cNvPr id="20" name="Picture 19">
                    <a:extLst>
                      <a:ext uri="{FF2B5EF4-FFF2-40B4-BE49-F238E27FC236}">
                        <a16:creationId xmlns:a16="http://schemas.microsoft.com/office/drawing/2014/main" id="{74949479-70ED-5A65-6A9D-A9AF8A3A230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4712834" y="4937427"/>
                    <a:ext cx="1370236" cy="1551080"/>
                  </a:xfrm>
                  <a:prstGeom prst="rect">
                    <a:avLst/>
                  </a:prstGeom>
                </p:spPr>
              </p:pic>
            </p:grpSp>
          </p:grp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D3192B28-41C6-DE91-85AC-996D917EA0AA}"/>
                  </a:ext>
                </a:extLst>
              </p:cNvPr>
              <p:cNvGrpSpPr/>
              <p:nvPr/>
            </p:nvGrpSpPr>
            <p:grpSpPr>
              <a:xfrm>
                <a:off x="32696" y="4117655"/>
                <a:ext cx="5985063" cy="3156541"/>
                <a:chOff x="-1091402" y="769744"/>
                <a:chExt cx="7893465" cy="4193134"/>
              </a:xfrm>
            </p:grpSpPr>
            <p:grpSp>
              <p:nvGrpSpPr>
                <p:cNvPr id="23" name="Group 22">
                  <a:extLst>
                    <a:ext uri="{FF2B5EF4-FFF2-40B4-BE49-F238E27FC236}">
                      <a16:creationId xmlns:a16="http://schemas.microsoft.com/office/drawing/2014/main" id="{16DC51D4-D5C2-1ECC-E41A-E4CD2F207C21}"/>
                    </a:ext>
                  </a:extLst>
                </p:cNvPr>
                <p:cNvGrpSpPr/>
                <p:nvPr/>
              </p:nvGrpSpPr>
              <p:grpSpPr>
                <a:xfrm>
                  <a:off x="-1091402" y="769744"/>
                  <a:ext cx="7803632" cy="3317785"/>
                  <a:chOff x="-1091402" y="769744"/>
                  <a:chExt cx="7803632" cy="3317785"/>
                </a:xfrm>
              </p:grpSpPr>
              <p:grpSp>
                <p:nvGrpSpPr>
                  <p:cNvPr id="27" name="Group 26">
                    <a:extLst>
                      <a:ext uri="{FF2B5EF4-FFF2-40B4-BE49-F238E27FC236}">
                        <a16:creationId xmlns:a16="http://schemas.microsoft.com/office/drawing/2014/main" id="{9C9AD6C5-A6AF-CD4E-C869-919E6103F6A2}"/>
                      </a:ext>
                    </a:extLst>
                  </p:cNvPr>
                  <p:cNvGrpSpPr/>
                  <p:nvPr/>
                </p:nvGrpSpPr>
                <p:grpSpPr>
                  <a:xfrm>
                    <a:off x="-1091402" y="769744"/>
                    <a:ext cx="7461558" cy="3317785"/>
                    <a:chOff x="-1091402" y="803197"/>
                    <a:chExt cx="7461558" cy="3317785"/>
                  </a:xfrm>
                </p:grpSpPr>
                <p:grpSp>
                  <p:nvGrpSpPr>
                    <p:cNvPr id="31" name="Group 30">
                      <a:extLst>
                        <a:ext uri="{FF2B5EF4-FFF2-40B4-BE49-F238E27FC236}">
                          <a16:creationId xmlns:a16="http://schemas.microsoft.com/office/drawing/2014/main" id="{4A025965-4AEA-2AD8-97EB-EBE50DB4C95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1091402" y="803197"/>
                      <a:ext cx="7461558" cy="850167"/>
                      <a:chOff x="-1091402" y="803197"/>
                      <a:chExt cx="7461558" cy="850167"/>
                    </a:xfrm>
                  </p:grpSpPr>
                  <p:sp>
                    <p:nvSpPr>
                      <p:cNvPr id="34" name="TextBox 33">
                        <a:extLst>
                          <a:ext uri="{FF2B5EF4-FFF2-40B4-BE49-F238E27FC236}">
                            <a16:creationId xmlns:a16="http://schemas.microsoft.com/office/drawing/2014/main" id="{881B820E-EB99-DE62-0A79-FEF8E5B2DC6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89734" y="803197"/>
                        <a:ext cx="843964" cy="3475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trong</a:t>
                        </a:r>
                      </a:p>
                    </p:txBody>
                  </p:sp>
                  <p:sp>
                    <p:nvSpPr>
                      <p:cNvPr id="35" name="TextBox 34">
                        <a:extLst>
                          <a:ext uri="{FF2B5EF4-FFF2-40B4-BE49-F238E27FC236}">
                            <a16:creationId xmlns:a16="http://schemas.microsoft.com/office/drawing/2014/main" id="{C33FF2A0-539F-6FC8-BCF5-249D43A3479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985028" y="803197"/>
                        <a:ext cx="1070178" cy="3475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oderate</a:t>
                        </a:r>
                      </a:p>
                    </p:txBody>
                  </p:sp>
                  <p:sp>
                    <p:nvSpPr>
                      <p:cNvPr id="36" name="TextBox 35">
                        <a:extLst>
                          <a:ext uri="{FF2B5EF4-FFF2-40B4-BE49-F238E27FC236}">
                            <a16:creationId xmlns:a16="http://schemas.microsoft.com/office/drawing/2014/main" id="{E4CA6BA2-12AB-B174-1079-FBC50226C23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640355" y="803197"/>
                        <a:ext cx="729801" cy="3475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Weak</a:t>
                        </a:r>
                      </a:p>
                    </p:txBody>
                  </p:sp>
                  <p:sp>
                    <p:nvSpPr>
                      <p:cNvPr id="37" name="TextBox 36">
                        <a:extLst>
                          <a:ext uri="{FF2B5EF4-FFF2-40B4-BE49-F238E27FC236}">
                            <a16:creationId xmlns:a16="http://schemas.microsoft.com/office/drawing/2014/main" id="{B9AC3CEE-0F80-1B34-16E0-1A770E6B577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-1091402" y="1305843"/>
                        <a:ext cx="1772072" cy="3475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umor vs Stroma</a:t>
                        </a:r>
                      </a:p>
                    </p:txBody>
                  </p:sp>
                </p:grpSp>
                <p:sp>
                  <p:nvSpPr>
                    <p:cNvPr id="32" name="TextBox 31">
                      <a:extLst>
                        <a:ext uri="{FF2B5EF4-FFF2-40B4-BE49-F238E27FC236}">
                          <a16:creationId xmlns:a16="http://schemas.microsoft.com/office/drawing/2014/main" id="{2C28C732-D50D-6D36-4586-7E4BD880D34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285640" y="1956732"/>
                      <a:ext cx="750942" cy="3475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</a:t>
                      </a:r>
                    </a:p>
                  </p:txBody>
                </p:sp>
                <p:sp>
                  <p:nvSpPr>
                    <p:cNvPr id="33" name="TextBox 32">
                      <a:extLst>
                        <a:ext uri="{FF2B5EF4-FFF2-40B4-BE49-F238E27FC236}">
                          <a16:creationId xmlns:a16="http://schemas.microsoft.com/office/drawing/2014/main" id="{FD35A016-3964-BE95-ED1C-5242305B941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285640" y="3773461"/>
                      <a:ext cx="750942" cy="3475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X2</a:t>
                      </a:r>
                    </a:p>
                  </p:txBody>
                </p:sp>
              </p:grpSp>
              <p:pic>
                <p:nvPicPr>
                  <p:cNvPr id="28" name="Picture 27">
                    <a:extLst>
                      <a:ext uri="{FF2B5EF4-FFF2-40B4-BE49-F238E27FC236}">
                        <a16:creationId xmlns:a16="http://schemas.microsoft.com/office/drawing/2014/main" id="{5E1B78C4-6257-8E02-3EF1-EB8D6910472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669410" y="1043959"/>
                    <a:ext cx="1467465" cy="2018694"/>
                  </a:xfrm>
                  <a:prstGeom prst="rect">
                    <a:avLst/>
                  </a:prstGeom>
                </p:spPr>
              </p:pic>
              <p:pic>
                <p:nvPicPr>
                  <p:cNvPr id="29" name="Picture 28">
                    <a:extLst>
                      <a:ext uri="{FF2B5EF4-FFF2-40B4-BE49-F238E27FC236}">
                        <a16:creationId xmlns:a16="http://schemas.microsoft.com/office/drawing/2014/main" id="{2B5F8146-1A66-9F82-E79B-477BA378A6A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2623441" y="1212118"/>
                    <a:ext cx="1611118" cy="1890597"/>
                  </a:xfrm>
                  <a:prstGeom prst="rect">
                    <a:avLst/>
                  </a:prstGeom>
                </p:spPr>
              </p:pic>
              <p:pic>
                <p:nvPicPr>
                  <p:cNvPr id="30" name="Picture 29">
                    <a:extLst>
                      <a:ext uri="{FF2B5EF4-FFF2-40B4-BE49-F238E27FC236}">
                        <a16:creationId xmlns:a16="http://schemas.microsoft.com/office/drawing/2014/main" id="{AAA6BFE5-4381-3E58-49B7-4083B98E45F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5166376" y="1108506"/>
                    <a:ext cx="1545854" cy="1971753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24" name="Picture 23">
                  <a:extLst>
                    <a:ext uri="{FF2B5EF4-FFF2-40B4-BE49-F238E27FC236}">
                      <a16:creationId xmlns:a16="http://schemas.microsoft.com/office/drawing/2014/main" id="{9D5F1515-D02F-C510-D291-93B1C8F6C95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633252" y="3085359"/>
                  <a:ext cx="1529830" cy="1877519"/>
                </a:xfrm>
                <a:prstGeom prst="rect">
                  <a:avLst/>
                </a:prstGeom>
              </p:spPr>
            </p:pic>
            <p:pic>
              <p:nvPicPr>
                <p:cNvPr id="25" name="Picture 24">
                  <a:extLst>
                    <a:ext uri="{FF2B5EF4-FFF2-40B4-BE49-F238E27FC236}">
                      <a16:creationId xmlns:a16="http://schemas.microsoft.com/office/drawing/2014/main" id="{004AD701-DB5F-0C37-DD61-1D53F4E2916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2657948" y="3025392"/>
                  <a:ext cx="1555528" cy="1934540"/>
                </a:xfrm>
                <a:prstGeom prst="rect">
                  <a:avLst/>
                </a:prstGeom>
              </p:spPr>
            </p:pic>
            <p:pic>
              <p:nvPicPr>
                <p:cNvPr id="26" name="Picture 25">
                  <a:extLst>
                    <a:ext uri="{FF2B5EF4-FFF2-40B4-BE49-F238E27FC236}">
                      <a16:creationId xmlns:a16="http://schemas.microsoft.com/office/drawing/2014/main" id="{314C42E9-B784-137E-9D13-8452E3BB8EF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5184260" y="3094505"/>
                  <a:ext cx="1617803" cy="1865427"/>
                </a:xfrm>
                <a:prstGeom prst="rect">
                  <a:avLst/>
                </a:prstGeom>
              </p:spPr>
            </p:pic>
          </p:grp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F740088C-D584-AF94-0F3B-EE6D4E2B4354}"/>
                  </a:ext>
                </a:extLst>
              </p:cNvPr>
              <p:cNvSpPr txBox="1"/>
              <p:nvPr/>
            </p:nvSpPr>
            <p:spPr>
              <a:xfrm>
                <a:off x="237394" y="7152274"/>
                <a:ext cx="2818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48F44E1F-ACCB-1003-2D9B-A96AB3518F22}"/>
                  </a:ext>
                </a:extLst>
              </p:cNvPr>
              <p:cNvGrpSpPr/>
              <p:nvPr/>
            </p:nvGrpSpPr>
            <p:grpSpPr>
              <a:xfrm>
                <a:off x="1108042" y="7316672"/>
                <a:ext cx="4757643" cy="261610"/>
                <a:chOff x="729407" y="5647966"/>
                <a:chExt cx="5854438" cy="334622"/>
              </a:xfrm>
            </p:grpSpPr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750441FE-3A0F-B344-D9BC-95831EECF9E2}"/>
                    </a:ext>
                  </a:extLst>
                </p:cNvPr>
                <p:cNvSpPr txBox="1"/>
                <p:nvPr/>
              </p:nvSpPr>
              <p:spPr>
                <a:xfrm>
                  <a:off x="729407" y="5647966"/>
                  <a:ext cx="787442" cy="3346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rong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88FAC5B8-B8E8-B6F6-E45A-04017EAB8B75}"/>
                    </a:ext>
                  </a:extLst>
                </p:cNvPr>
                <p:cNvSpPr txBox="1"/>
                <p:nvPr/>
              </p:nvSpPr>
              <p:spPr>
                <a:xfrm>
                  <a:off x="3130103" y="5647966"/>
                  <a:ext cx="998505" cy="3346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derate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94E04186-4933-6DCA-E4D9-67BA53667383}"/>
                    </a:ext>
                  </a:extLst>
                </p:cNvPr>
                <p:cNvSpPr txBox="1"/>
                <p:nvPr/>
              </p:nvSpPr>
              <p:spPr>
                <a:xfrm>
                  <a:off x="5902921" y="5647966"/>
                  <a:ext cx="680924" cy="3346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eak</a:t>
                  </a:r>
                </a:p>
              </p:txBody>
            </p:sp>
          </p:grp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2F41772C-9ECB-69B1-D66D-540132F0D268}"/>
                  </a:ext>
                </a:extLst>
              </p:cNvPr>
              <p:cNvSpPr txBox="1"/>
              <p:nvPr/>
            </p:nvSpPr>
            <p:spPr>
              <a:xfrm>
                <a:off x="287077" y="4155256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EA2BC53-FBDA-FC53-7BE3-CCD9E2776F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t="11291"/>
            <a:stretch/>
          </p:blipFill>
          <p:spPr>
            <a:xfrm>
              <a:off x="449522" y="6710222"/>
              <a:ext cx="2048434" cy="1423219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CDBD47A-AB15-36B6-1F71-24C0AAA25602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677423" y="6700969"/>
              <a:ext cx="2048434" cy="1432471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EB96FE0A-452C-9837-4AE3-E38F242F34D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565754" y="6709136"/>
              <a:ext cx="2036757" cy="142430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2807000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359</TotalTime>
  <Words>22</Words>
  <Application>Microsoft Macintosh PowerPoint</Application>
  <PresentationFormat>Letter Paper (8.5x11 in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dnour, Lisa (NIH/NCI) [E]</dc:creator>
  <cp:lastModifiedBy>Ridnour, Lisa (NIH/NCI) [E]</cp:lastModifiedBy>
  <cp:revision>6</cp:revision>
  <cp:lastPrinted>2023-03-17T22:25:36Z</cp:lastPrinted>
  <dcterms:created xsi:type="dcterms:W3CDTF">2022-12-16T17:41:13Z</dcterms:created>
  <dcterms:modified xsi:type="dcterms:W3CDTF">2023-03-21T21:14:08Z</dcterms:modified>
</cp:coreProperties>
</file>